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sldIdLst>
    <p:sldId id="338" r:id="rId2"/>
    <p:sldId id="332" r:id="rId3"/>
    <p:sldId id="333" r:id="rId4"/>
    <p:sldId id="330" r:id="rId5"/>
    <p:sldId id="334" r:id="rId6"/>
    <p:sldId id="336" r:id="rId7"/>
    <p:sldId id="337" r:id="rId8"/>
  </p:sldIdLst>
  <p:sldSz cx="6858000" cy="9906000" type="A4"/>
  <p:notesSz cx="9939338" cy="6807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CE223A5-E15A-5741-96E5-EFFB12457DCB}" name="Liao Yiyu" initials="L." userId="S::yiyu.liao@staff.main.ntu.edu.sg::1ff73f8d-c27d-45cd-b560-c2d31c9b1466" providerId="AD"/>
  <p188:author id="{53AA06C7-7B71-4900-EE8A-74B92E0AE167}" name="Chang Zi Wei" initials="ZC" userId="S::changzw@idlabs.a-star.edu.sg::cf61d5e3-cdda-44f8-a9a0-f4282cf7e496" providerId="AD"/>
  <p188:author id="{48D164FA-4A69-DC40-7DBF-C357C94E6927}" name="Keisuke Ejima (Asst Prof)" initials="KE" userId="S::keisuke.ejima@staff.main.ntu.edu.sg::ebcf1754-7851-4ef0-8d99-3501e20c73a9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hang Zi Wei" initials="CZW" lastIdx="7" clrIdx="0">
    <p:extLst>
      <p:ext uri="{19B8F6BF-5375-455C-9EA6-DF929625EA0E}">
        <p15:presenceInfo xmlns:p15="http://schemas.microsoft.com/office/powerpoint/2012/main" userId="S::changzw@idlabs.a-star.edu.sg::cf61d5e3-cdda-44f8-a9a0-f4282cf7e49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1" d="100"/>
          <a:sy n="41" d="100"/>
        </p:scale>
        <p:origin x="2292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microsoft.com/office/2018/10/relationships/authors" Target="author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ang Zi Wei" userId="cf61d5e3-cdda-44f8-a9a0-f4282cf7e496" providerId="ADAL" clId="{489C1FCE-B5C2-4C64-BC4A-81B930FCC7DA}"/>
    <pc:docChg chg="modSld">
      <pc:chgData name="Chang Zi Wei" userId="cf61d5e3-cdda-44f8-a9a0-f4282cf7e496" providerId="ADAL" clId="{489C1FCE-B5C2-4C64-BC4A-81B930FCC7DA}" dt="2026-03-05T15:48:09.786" v="1" actId="13926"/>
      <pc:docMkLst>
        <pc:docMk/>
      </pc:docMkLst>
      <pc:sldChg chg="modSp mod">
        <pc:chgData name="Chang Zi Wei" userId="cf61d5e3-cdda-44f8-a9a0-f4282cf7e496" providerId="ADAL" clId="{489C1FCE-B5C2-4C64-BC4A-81B930FCC7DA}" dt="2026-03-05T15:48:09.786" v="1" actId="13926"/>
        <pc:sldMkLst>
          <pc:docMk/>
          <pc:sldMk cId="391031430" sldId="337"/>
        </pc:sldMkLst>
        <pc:spChg chg="mod">
          <ac:chgData name="Chang Zi Wei" userId="cf61d5e3-cdda-44f8-a9a0-f4282cf7e496" providerId="ADAL" clId="{489C1FCE-B5C2-4C64-BC4A-81B930FCC7DA}" dt="2026-03-05T15:48:09.786" v="1" actId="13926"/>
          <ac:spMkLst>
            <pc:docMk/>
            <pc:sldMk cId="391031430" sldId="337"/>
            <ac:spMk id="2" creationId="{BE766819-2A1A-9E86-0A67-15897ECD73B7}"/>
          </ac:spMkLst>
        </pc:spChg>
      </pc:sldChg>
      <pc:sldChg chg="modSp mod">
        <pc:chgData name="Chang Zi Wei" userId="cf61d5e3-cdda-44f8-a9a0-f4282cf7e496" providerId="ADAL" clId="{489C1FCE-B5C2-4C64-BC4A-81B930FCC7DA}" dt="2026-03-05T15:47:58.061" v="0" actId="13926"/>
        <pc:sldMkLst>
          <pc:docMk/>
          <pc:sldMk cId="3909994671" sldId="338"/>
        </pc:sldMkLst>
        <pc:spChg chg="mod">
          <ac:chgData name="Chang Zi Wei" userId="cf61d5e3-cdda-44f8-a9a0-f4282cf7e496" providerId="ADAL" clId="{489C1FCE-B5C2-4C64-BC4A-81B930FCC7DA}" dt="2026-03-05T15:47:58.061" v="0" actId="13926"/>
          <ac:spMkLst>
            <pc:docMk/>
            <pc:sldMk cId="3909994671" sldId="338"/>
            <ac:spMk id="2" creationId="{7C6E46C9-401E-16BB-E09C-5EDBCE42F832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7047" cy="34154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SG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9993" y="0"/>
            <a:ext cx="4307047" cy="34154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3C08C0-EE98-4AA6-AFB8-E82292ECDB3A}" type="datetimeFigureOut">
              <a:rPr lang="en-SG" smtClean="0"/>
              <a:t>5/3/2026</a:t>
            </a:fld>
            <a:endParaRPr lang="en-SG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175125" y="850900"/>
            <a:ext cx="1589088" cy="22971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SG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3935" y="3275966"/>
            <a:ext cx="7951470" cy="268033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6465659"/>
            <a:ext cx="4307047" cy="34154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9993" y="6465659"/>
            <a:ext cx="4307047" cy="34154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84BC92-FC90-4336-A6C4-917AD7B7BDF1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1063237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6B2E2F3-7068-BFEE-74DE-A1C794B1C44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D946A926-DBD6-782F-DCE0-2DE4CFFF7DC9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E3BCA110-3B2A-D1B7-06B3-6A68BACA9BB9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3F4D94D-4BEC-A2AB-9AA4-3A8229D0C3B2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A84BC92-FC90-4336-A6C4-917AD7B7BDF1}" type="slidenum">
              <a:rPr lang="en-SG" smtClean="0"/>
              <a:t>1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8777110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A84BC92-FC90-4336-A6C4-917AD7B7BDF1}" type="slidenum">
              <a:rPr lang="en-SG" smtClean="0"/>
              <a:t>2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19375767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A84BC92-FC90-4336-A6C4-917AD7B7BDF1}" type="slidenum">
              <a:rPr lang="en-SG" smtClean="0"/>
              <a:t>3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80880508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A84BC92-FC90-4336-A6C4-917AD7B7BDF1}" type="slidenum">
              <a:rPr lang="en-SG" smtClean="0"/>
              <a:t>4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12642692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A84BC92-FC90-4336-A6C4-917AD7B7BDF1}" type="slidenum">
              <a:rPr lang="en-SG" smtClean="0"/>
              <a:t>5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95472838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38711D5-BF6A-B403-5482-61BD449DB36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7450DD9B-793C-ADBC-EA06-20D2D93C8FA2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662516EB-A35B-D65D-961C-2DE45199975C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EFCA7B3-C0E8-D5C2-1736-A31B50FDF53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A84BC92-FC90-4336-A6C4-917AD7B7BDF1}" type="slidenum">
              <a:rPr lang="en-SG" smtClean="0"/>
              <a:t>6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33313223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2D84F2A-D217-D7BD-CC44-C0191361928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7B77DEED-8238-DF82-0A63-B5445718BEBC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63F05202-8337-6AB8-F5F1-0C3BF5FACF26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7D73B51-4D4B-866E-BF13-204441D9369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A84BC92-FC90-4336-A6C4-917AD7B7BDF1}" type="slidenum">
              <a:rPr lang="en-SG" smtClean="0"/>
              <a:t>7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5038101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199AA-95D7-40D8-BEB4-1B0E49EA9D0C}" type="datetimeFigureOut">
              <a:rPr lang="en-SG" smtClean="0"/>
              <a:t>5/3/2026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ED6D5-D41C-4F14-A249-50F0D078A45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1261984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199AA-95D7-40D8-BEB4-1B0E49EA9D0C}" type="datetimeFigureOut">
              <a:rPr lang="en-SG" smtClean="0"/>
              <a:t>5/3/2026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ED6D5-D41C-4F14-A249-50F0D078A45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2163703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199AA-95D7-40D8-BEB4-1B0E49EA9D0C}" type="datetimeFigureOut">
              <a:rPr lang="en-SG" smtClean="0"/>
              <a:t>5/3/2026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ED6D5-D41C-4F14-A249-50F0D078A45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2091712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199AA-95D7-40D8-BEB4-1B0E49EA9D0C}" type="datetimeFigureOut">
              <a:rPr lang="en-SG" smtClean="0"/>
              <a:t>5/3/2026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ED6D5-D41C-4F14-A249-50F0D078A45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4686673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199AA-95D7-40D8-BEB4-1B0E49EA9D0C}" type="datetimeFigureOut">
              <a:rPr lang="en-SG" smtClean="0"/>
              <a:t>5/3/2026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ED6D5-D41C-4F14-A249-50F0D078A45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1644079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199AA-95D7-40D8-BEB4-1B0E49EA9D0C}" type="datetimeFigureOut">
              <a:rPr lang="en-SG" smtClean="0"/>
              <a:t>5/3/2026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ED6D5-D41C-4F14-A249-50F0D078A45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48046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199AA-95D7-40D8-BEB4-1B0E49EA9D0C}" type="datetimeFigureOut">
              <a:rPr lang="en-SG" smtClean="0"/>
              <a:t>5/3/2026</a:t>
            </a:fld>
            <a:endParaRPr lang="en-SG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ED6D5-D41C-4F14-A249-50F0D078A45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9907737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199AA-95D7-40D8-BEB4-1B0E49EA9D0C}" type="datetimeFigureOut">
              <a:rPr lang="en-SG" smtClean="0"/>
              <a:t>5/3/2026</a:t>
            </a:fld>
            <a:endParaRPr lang="en-S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ED6D5-D41C-4F14-A249-50F0D078A45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117002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199AA-95D7-40D8-BEB4-1B0E49EA9D0C}" type="datetimeFigureOut">
              <a:rPr lang="en-SG" smtClean="0"/>
              <a:t>5/3/2026</a:t>
            </a:fld>
            <a:endParaRPr lang="en-SG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ED6D5-D41C-4F14-A249-50F0D078A45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5740855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199AA-95D7-40D8-BEB4-1B0E49EA9D0C}" type="datetimeFigureOut">
              <a:rPr lang="en-SG" smtClean="0"/>
              <a:t>5/3/2026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ED6D5-D41C-4F14-A249-50F0D078A45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2242879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199AA-95D7-40D8-BEB4-1B0E49EA9D0C}" type="datetimeFigureOut">
              <a:rPr lang="en-SG" smtClean="0"/>
              <a:t>5/3/2026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ED6D5-D41C-4F14-A249-50F0D078A45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934354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3199AA-95D7-40D8-BEB4-1B0E49EA9D0C}" type="datetimeFigureOut">
              <a:rPr lang="en-SG" smtClean="0"/>
              <a:t>5/3/2026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FED6D5-D41C-4F14-A249-50F0D078A45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3563675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14FD69C-EE78-6DC6-A156-07C02E04C39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EACEDA7C-FFD2-9B60-D5E6-6A025EBDC98A}"/>
              </a:ext>
            </a:extLst>
          </p:cNvPr>
          <p:cNvSpPr txBox="1"/>
          <p:nvPr/>
        </p:nvSpPr>
        <p:spPr>
          <a:xfrm>
            <a:off x="843219" y="64628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SG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A814F7C-B56D-9BFC-A468-881AFDC603FD}"/>
              </a:ext>
            </a:extLst>
          </p:cNvPr>
          <p:cNvSpPr txBox="1"/>
          <p:nvPr/>
        </p:nvSpPr>
        <p:spPr>
          <a:xfrm>
            <a:off x="3490011" y="61038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SG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E87CA85-6D3C-A7DD-37C8-657867379E0E}"/>
              </a:ext>
            </a:extLst>
          </p:cNvPr>
          <p:cNvSpPr txBox="1"/>
          <p:nvPr/>
        </p:nvSpPr>
        <p:spPr>
          <a:xfrm>
            <a:off x="951826" y="317741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SG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616E816-0656-523E-2563-266FC9CC3508}"/>
              </a:ext>
            </a:extLst>
          </p:cNvPr>
          <p:cNvSpPr txBox="1"/>
          <p:nvPr/>
        </p:nvSpPr>
        <p:spPr>
          <a:xfrm>
            <a:off x="3763746" y="318932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SG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C6E46C9-401E-16BB-E09C-5EDBCE42F832}"/>
              </a:ext>
            </a:extLst>
          </p:cNvPr>
          <p:cNvSpPr txBox="1"/>
          <p:nvPr/>
        </p:nvSpPr>
        <p:spPr>
          <a:xfrm>
            <a:off x="335157" y="5580174"/>
            <a:ext cx="618768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SG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Comparison of cross-reactivity humoral responses of mice vaccinated with 2 doses of 1 </a:t>
            </a:r>
            <a:r>
              <a:rPr lang="en-SG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SG" sz="1200" b="1" dirty="0">
                <a:latin typeface="Arial" panose="020B0604020202020204" pitchFamily="34" charset="0"/>
                <a:cs typeface="Arial" panose="020B0604020202020204" pitchFamily="34" charset="0"/>
              </a:rPr>
              <a:t> of BNT162b2 up to 16 weeks.</a:t>
            </a:r>
          </a:p>
          <a:p>
            <a:pPr algn="just"/>
            <a:endParaRPr lang="en-SG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Longitudinal IgG binding antibodies responses against ancestral, Delta, Omicron BA.1 and EG5.1 strain full-length spike full-length spike in mice immunised with 2 doses of 0.05 (B) or 1 </a:t>
            </a:r>
            <a:r>
              <a:rPr lang="en-SG" sz="1200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 (A) of BNT162b2. Longitudinal IgG neutralizing antibodies responses against ancestral, Delta, Omicron BA.1 and EG5.1 strain full-length spike full-length spike in mice immunised with 2 doses of 0.05 (D) or 1 </a:t>
            </a:r>
            <a:r>
              <a:rPr lang="en-SG" sz="1200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 (C) of BNT162b2. Data are presented as median. The dotted line in each panel denotes the assays lower limit of detection. 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EBDAD6CB-2468-3B8F-545A-9A58976C72B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7559"/>
          <a:stretch>
            <a:fillRect/>
          </a:stretch>
        </p:blipFill>
        <p:spPr>
          <a:xfrm>
            <a:off x="1018908" y="3594110"/>
            <a:ext cx="2101042" cy="182296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93DAB63-8AFE-22D2-8760-A042ED691809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6856"/>
          <a:stretch>
            <a:fillRect/>
          </a:stretch>
        </p:blipFill>
        <p:spPr>
          <a:xfrm>
            <a:off x="3626320" y="3558652"/>
            <a:ext cx="2125742" cy="185841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B2C1B95-E515-D52A-45F4-A24C71AB4D81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t="9780"/>
          <a:stretch>
            <a:fillRect/>
          </a:stretch>
        </p:blipFill>
        <p:spPr>
          <a:xfrm>
            <a:off x="951826" y="1043899"/>
            <a:ext cx="2520382" cy="2105237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31F3E95-192D-08AD-3EE6-8D0CF622195A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t="10187"/>
          <a:stretch>
            <a:fillRect/>
          </a:stretch>
        </p:blipFill>
        <p:spPr>
          <a:xfrm>
            <a:off x="3490011" y="1059880"/>
            <a:ext cx="2493364" cy="20732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99946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3C4AD02-8545-7BE5-CA57-C130947B218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452C8E4-8E0D-6805-6D12-D164A0B5159F}"/>
              </a:ext>
            </a:extLst>
          </p:cNvPr>
          <p:cNvSpPr txBox="1"/>
          <p:nvPr/>
        </p:nvSpPr>
        <p:spPr>
          <a:xfrm>
            <a:off x="209158" y="1588308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SG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4137E6B-A267-066A-A2D2-8EC621BF1CBA}"/>
              </a:ext>
            </a:extLst>
          </p:cNvPr>
          <p:cNvSpPr txBox="1"/>
          <p:nvPr/>
        </p:nvSpPr>
        <p:spPr>
          <a:xfrm>
            <a:off x="3593007" y="158830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SG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3735D66-B536-6AC6-3AED-6AFA2D4D3FBD}"/>
              </a:ext>
            </a:extLst>
          </p:cNvPr>
          <p:cNvSpPr txBox="1"/>
          <p:nvPr/>
        </p:nvSpPr>
        <p:spPr>
          <a:xfrm>
            <a:off x="162668" y="4236291"/>
            <a:ext cx="653266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SG" sz="1200" b="1">
                <a:latin typeface="Arial" panose="020B0604020202020204" pitchFamily="34" charset="0"/>
                <a:cs typeface="Arial" panose="020B0604020202020204" pitchFamily="34" charset="0"/>
              </a:rPr>
              <a:t>Supplementary Figure 2. Dose-parameter dependency in mice.</a:t>
            </a:r>
          </a:p>
          <a:p>
            <a:pPr algn="just"/>
            <a:endParaRPr lang="en-SG" sz="12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SG" sz="1200">
                <a:latin typeface="Arial" panose="020B0604020202020204" pitchFamily="34" charset="0"/>
                <a:cs typeface="Arial" panose="020B0604020202020204" pitchFamily="34" charset="0"/>
              </a:rPr>
              <a:t>(A) Linear model of k_1 against dose. (B) Power-law model of k_2 against dose. Model selection details can be found in Supplementary Table 3.</a:t>
            </a:r>
          </a:p>
        </p:txBody>
      </p:sp>
      <p:pic>
        <p:nvPicPr>
          <p:cNvPr id="11" name="Picture 10" descr="A graph with red dots&#10;&#10;AI-generated content may be incorrect.">
            <a:extLst>
              <a:ext uri="{FF2B5EF4-FFF2-40B4-BE49-F238E27FC236}">
                <a16:creationId xmlns:a16="http://schemas.microsoft.com/office/drawing/2014/main" id="{FF56CB86-EB45-DC67-07F1-72AF197EB4C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103120"/>
            <a:ext cx="3312821" cy="1987693"/>
          </a:xfrm>
          <a:prstGeom prst="rect">
            <a:avLst/>
          </a:prstGeom>
        </p:spPr>
      </p:pic>
      <p:pic>
        <p:nvPicPr>
          <p:cNvPr id="13" name="Picture 12" descr="A graph of a function&#10;&#10;AI-generated content may be incorrect.">
            <a:extLst>
              <a:ext uri="{FF2B5EF4-FFF2-40B4-BE49-F238E27FC236}">
                <a16:creationId xmlns:a16="http://schemas.microsoft.com/office/drawing/2014/main" id="{658BDD9A-A952-A1E9-D4C7-A51D6464D7C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2103119"/>
            <a:ext cx="3312821" cy="19876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47294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hart of different colored lines&#10;&#10;AI-generated content may be incorrect.">
            <a:extLst>
              <a:ext uri="{FF2B5EF4-FFF2-40B4-BE49-F238E27FC236}">
                <a16:creationId xmlns:a16="http://schemas.microsoft.com/office/drawing/2014/main" id="{5C7D7BE1-58E6-AB00-79C7-866D336DEE5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360" y="811530"/>
            <a:ext cx="6096000" cy="4572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45F787D-2ABF-2A4D-F07C-CD6A005DBB7F}"/>
              </a:ext>
            </a:extLst>
          </p:cNvPr>
          <p:cNvSpPr txBox="1"/>
          <p:nvPr/>
        </p:nvSpPr>
        <p:spPr>
          <a:xfrm>
            <a:off x="548639" y="5383530"/>
            <a:ext cx="576072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SG" sz="1200" b="1">
                <a:latin typeface="Arial" panose="020B0604020202020204" pitchFamily="34" charset="0"/>
                <a:cs typeface="Arial" panose="020B0604020202020204" pitchFamily="34" charset="0"/>
              </a:rPr>
              <a:t>Supplementary Figure 3. Individual fits of anti-spike IgG trajectories for mice vaccinated with the BNT162b2 vaccine across different doses. </a:t>
            </a:r>
          </a:p>
          <a:p>
            <a:pPr algn="just"/>
            <a:endParaRPr lang="en-SG" sz="12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SG" sz="1200">
                <a:latin typeface="Arial" panose="020B0604020202020204" pitchFamily="34" charset="0"/>
                <a:cs typeface="Arial" panose="020B0604020202020204" pitchFamily="34" charset="0"/>
              </a:rPr>
              <a:t>Each subplot represents one mouse (n = 25), showing anti-spike IgG binding percentages over time (days after the first dose, with the second dose at 21 days) for doses of 0.05 </a:t>
            </a:r>
            <a:r>
              <a:rPr lang="en-SG" sz="120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SG" sz="1200">
                <a:latin typeface="Arial" panose="020B0604020202020204" pitchFamily="34" charset="0"/>
                <a:cs typeface="Arial" panose="020B0604020202020204" pitchFamily="34" charset="0"/>
              </a:rPr>
              <a:t> (red), 0.1 </a:t>
            </a:r>
            <a:r>
              <a:rPr lang="en-SG" sz="120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SG" sz="1200">
                <a:latin typeface="Arial" panose="020B0604020202020204" pitchFamily="34" charset="0"/>
                <a:cs typeface="Arial" panose="020B0604020202020204" pitchFamily="34" charset="0"/>
              </a:rPr>
              <a:t> (yellow), 0.2 </a:t>
            </a:r>
            <a:r>
              <a:rPr lang="en-SG" sz="120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SG" sz="1200">
                <a:latin typeface="Arial" panose="020B0604020202020204" pitchFamily="34" charset="0"/>
                <a:cs typeface="Arial" panose="020B0604020202020204" pitchFamily="34" charset="0"/>
              </a:rPr>
              <a:t> (green), 0.5 </a:t>
            </a:r>
            <a:r>
              <a:rPr lang="en-SG" sz="120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SG" sz="1200">
                <a:latin typeface="Arial" panose="020B0604020202020204" pitchFamily="34" charset="0"/>
                <a:cs typeface="Arial" panose="020B0604020202020204" pitchFamily="34" charset="0"/>
              </a:rPr>
              <a:t> (blue), and 1 </a:t>
            </a:r>
            <a:r>
              <a:rPr lang="en-SG" sz="120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SG" sz="1200">
                <a:latin typeface="Arial" panose="020B0604020202020204" pitchFamily="34" charset="0"/>
                <a:cs typeface="Arial" panose="020B0604020202020204" pitchFamily="34" charset="0"/>
              </a:rPr>
              <a:t> (purple). Trajectories were fitted using the mathematical model, with shaded areas indicating 95% confidence intervals. </a:t>
            </a:r>
          </a:p>
        </p:txBody>
      </p:sp>
    </p:spTree>
    <p:extLst>
      <p:ext uri="{BB962C8B-B14F-4D97-AF65-F5344CB8AC3E}">
        <p14:creationId xmlns:p14="http://schemas.microsoft.com/office/powerpoint/2010/main" val="14759349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hart of a graph&#10;&#10;AI-generated content may be incorrect.">
            <a:extLst>
              <a:ext uri="{FF2B5EF4-FFF2-40B4-BE49-F238E27FC236}">
                <a16:creationId xmlns:a16="http://schemas.microsoft.com/office/drawing/2014/main" id="{5879E07F-0C34-7C25-52FE-E1E72A35EDB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101" y="54429"/>
            <a:ext cx="6172201" cy="881743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E4F0AC2-FF09-9B61-62D0-70D15A4F2F8D}"/>
              </a:ext>
            </a:extLst>
          </p:cNvPr>
          <p:cNvSpPr txBox="1"/>
          <p:nvPr/>
        </p:nvSpPr>
        <p:spPr>
          <a:xfrm>
            <a:off x="213101" y="8794370"/>
            <a:ext cx="6482167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SG" sz="1050" b="1">
                <a:latin typeface="Arial" panose="020B0604020202020204" pitchFamily="34" charset="0"/>
                <a:cs typeface="Arial" panose="020B0604020202020204" pitchFamily="34" charset="0"/>
              </a:rPr>
              <a:t>Supplementary Figure 4. Individual fits of anti-spike IgG trajectories for human vaccinated with the 30 </a:t>
            </a:r>
            <a:r>
              <a:rPr lang="en-SG" sz="1050" b="1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SG" sz="1050" b="1">
                <a:latin typeface="Arial" panose="020B0604020202020204" pitchFamily="34" charset="0"/>
                <a:cs typeface="Arial" panose="020B0604020202020204" pitchFamily="34" charset="0"/>
              </a:rPr>
              <a:t> BNT162b2. </a:t>
            </a:r>
          </a:p>
          <a:p>
            <a:pPr algn="just"/>
            <a:endParaRPr lang="en-SG" sz="105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SG" sz="1050">
                <a:latin typeface="Arial" panose="020B0604020202020204" pitchFamily="34" charset="0"/>
                <a:cs typeface="Arial" panose="020B0604020202020204" pitchFamily="34" charset="0"/>
              </a:rPr>
              <a:t>Each subplot represents one person (n = 179), showing anti-spike IgG binding percentages over time (days after the first dose, with the second dose at 21 days) for doses of 30 </a:t>
            </a:r>
            <a:r>
              <a:rPr lang="en-SG" sz="105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SG" sz="1050">
                <a:latin typeface="Arial" panose="020B0604020202020204" pitchFamily="34" charset="0"/>
                <a:cs typeface="Arial" panose="020B0604020202020204" pitchFamily="34" charset="0"/>
              </a:rPr>
              <a:t>. Trajectories were fitted using the mathematical model, with shaded areas indicating 95% confidence intervals. </a:t>
            </a:r>
          </a:p>
        </p:txBody>
      </p:sp>
    </p:spTree>
    <p:extLst>
      <p:ext uri="{BB962C8B-B14F-4D97-AF65-F5344CB8AC3E}">
        <p14:creationId xmlns:p14="http://schemas.microsoft.com/office/powerpoint/2010/main" val="42837852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8888CDF-6E63-558A-8202-6D1263554575}"/>
              </a:ext>
            </a:extLst>
          </p:cNvPr>
          <p:cNvSpPr txBox="1"/>
          <p:nvPr/>
        </p:nvSpPr>
        <p:spPr>
          <a:xfrm>
            <a:off x="619931" y="6236312"/>
            <a:ext cx="564422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SG" sz="1200" b="1">
                <a:latin typeface="Arial" panose="020B0604020202020204" pitchFamily="34" charset="0"/>
                <a:cs typeface="Arial" panose="020B0604020202020204" pitchFamily="34" charset="0"/>
              </a:rPr>
              <a:t>Supplementary Figure 5. Comparison of the antibody trajectory across different translation factors for dose level.</a:t>
            </a:r>
          </a:p>
          <a:p>
            <a:pPr algn="just"/>
            <a:endParaRPr lang="en-SG" sz="12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SG" sz="1200">
                <a:latin typeface="Arial" panose="020B0604020202020204" pitchFamily="34" charset="0"/>
                <a:cs typeface="Arial" panose="020B0604020202020204" pitchFamily="34" charset="0"/>
              </a:rPr>
              <a:t>Illustration of the predicted IgG antibody trajectories over time 180 days for various vaccine dose levels (10 </a:t>
            </a:r>
            <a:r>
              <a:rPr lang="en-SG" sz="120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SG" sz="1200">
                <a:latin typeface="Arial" panose="020B0604020202020204" pitchFamily="34" charset="0"/>
                <a:cs typeface="Arial" panose="020B0604020202020204" pitchFamily="34" charset="0"/>
              </a:rPr>
              <a:t>, 20 </a:t>
            </a:r>
            <a:r>
              <a:rPr lang="en-SG" sz="120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SG" sz="1200">
                <a:latin typeface="Arial" panose="020B0604020202020204" pitchFamily="34" charset="0"/>
                <a:cs typeface="Arial" panose="020B0604020202020204" pitchFamily="34" charset="0"/>
              </a:rPr>
              <a:t>, 30 </a:t>
            </a:r>
            <a:r>
              <a:rPr lang="en-SG" sz="120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SG" sz="1200">
                <a:latin typeface="Arial" panose="020B0604020202020204" pitchFamily="34" charset="0"/>
                <a:cs typeface="Arial" panose="020B0604020202020204" pitchFamily="34" charset="0"/>
              </a:rPr>
              <a:t>, 40 </a:t>
            </a:r>
            <a:r>
              <a:rPr lang="en-SG" sz="120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SG" sz="1200">
                <a:latin typeface="Arial" panose="020B0604020202020204" pitchFamily="34" charset="0"/>
                <a:cs typeface="Arial" panose="020B0604020202020204" pitchFamily="34" charset="0"/>
              </a:rPr>
              <a:t>, and 50 </a:t>
            </a:r>
            <a:r>
              <a:rPr lang="en-SG" sz="120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SG" sz="1200">
                <a:latin typeface="Arial" panose="020B0604020202020204" pitchFamily="34" charset="0"/>
                <a:cs typeface="Arial" panose="020B0604020202020204" pitchFamily="34" charset="0"/>
              </a:rPr>
              <a:t>) in human under three different translation factors (50, 100, and 200).</a:t>
            </a:r>
          </a:p>
        </p:txBody>
      </p:sp>
      <p:pic>
        <p:nvPicPr>
          <p:cNvPr id="7" name="Picture 6" descr="A graph of a number of different types of numbers&#10;&#10;AI-generated content may be incorrect.">
            <a:extLst>
              <a:ext uri="{FF2B5EF4-FFF2-40B4-BE49-F238E27FC236}">
                <a16:creationId xmlns:a16="http://schemas.microsoft.com/office/drawing/2014/main" id="{B9A24E99-C5DF-83F9-9E18-9F15711635D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999" y="1718310"/>
            <a:ext cx="6024002" cy="45180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31615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286F899-18B8-94AB-486D-A01813F05A4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FC4C78D-E538-867B-6E92-68B96516AC2B}"/>
              </a:ext>
            </a:extLst>
          </p:cNvPr>
          <p:cNvSpPr txBox="1"/>
          <p:nvPr/>
        </p:nvSpPr>
        <p:spPr>
          <a:xfrm>
            <a:off x="557939" y="3781588"/>
            <a:ext cx="595134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SG" sz="1200" b="1">
                <a:latin typeface="Arial" panose="020B0604020202020204" pitchFamily="34" charset="0"/>
                <a:cs typeface="Arial" panose="020B0604020202020204" pitchFamily="34" charset="0"/>
              </a:rPr>
              <a:t>Supplementary Figure 6. Cell surface expression of SARS-CoV-2 EG5.1 spike.</a:t>
            </a:r>
          </a:p>
          <a:p>
            <a:pPr algn="just"/>
            <a:r>
              <a:rPr lang="en-SG" sz="120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algn="just"/>
            <a:r>
              <a:rPr lang="en-SG" sz="1200">
                <a:latin typeface="Arial" panose="020B0604020202020204" pitchFamily="34" charset="0"/>
                <a:cs typeface="Arial" panose="020B0604020202020204" pitchFamily="34" charset="0"/>
              </a:rPr>
              <a:t>Cell surface expression of SARS-CoV-2 EG5.1 spike was examined by SFB binding assay, where serially diluted ACE-2-HuFc was added to the cells, in place of plasma antibody. Bound ACE-2-HuFc were then detected by Alexa Fluor 647-conjugated anti-human IgG (1:500 dilution) and propidium iodide (PI; 1:2500 dilution). </a:t>
            </a:r>
          </a:p>
        </p:txBody>
      </p:sp>
      <p:pic>
        <p:nvPicPr>
          <p:cNvPr id="4" name="Picture 3" descr="A graph of a graph of a number of points">
            <a:extLst>
              <a:ext uri="{FF2B5EF4-FFF2-40B4-BE49-F238E27FC236}">
                <a16:creationId xmlns:a16="http://schemas.microsoft.com/office/drawing/2014/main" id="{6C193EC4-3544-0AE1-D40E-7D2E2280E7C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5622" y="395066"/>
            <a:ext cx="4826755" cy="32005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9977044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B0FE090-DC04-6790-57C5-6FA304B6E27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E766819-2A1A-9E86-0A67-15897ECD73B7}"/>
              </a:ext>
            </a:extLst>
          </p:cNvPr>
          <p:cNvSpPr txBox="1"/>
          <p:nvPr/>
        </p:nvSpPr>
        <p:spPr>
          <a:xfrm>
            <a:off x="467253" y="2925061"/>
            <a:ext cx="5761568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SG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. Comparison of antibody model parameters (k1 and k2) across human and mice groups with varying doses.</a:t>
            </a:r>
          </a:p>
          <a:p>
            <a:pPr algn="just"/>
            <a:endParaRPr lang="en-SG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Boxplots display antibody model parameters k1 (growth rate) and k2 (decay rate), estimated from real-world data (shown as overlaid data points) for humans (30 µg) and mice with doses of 0.05 µg, 0.1 µg, 0.2 µg, 0.5 µg, and 1 µg. (A) Growth rate k1 with pairwise Welch’s two-sample t-test indicating significant differences (p &lt; 0.05) across all mouse groups compared to the human response. (B) Decay rate k2 with Welch’s two-sample t-test results. Except for 0.05 </a:t>
            </a:r>
            <a:r>
              <a:rPr lang="en-SG" sz="1200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 mice group, the other groups revealed significant differences compared to human response. P-values are represented by asterisks where * p &lt; 0.05, ** p &lt; 0.01, *** p &lt; 0.001, and **** p &lt; 0.0001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6A91AD9-6F9E-602D-557B-20EF2A594A67}"/>
              </a:ext>
            </a:extLst>
          </p:cNvPr>
          <p:cNvSpPr txBox="1"/>
          <p:nvPr/>
        </p:nvSpPr>
        <p:spPr>
          <a:xfrm>
            <a:off x="209158" y="248908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SG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DB6A620-D078-9EAC-98D7-31333E76913D}"/>
              </a:ext>
            </a:extLst>
          </p:cNvPr>
          <p:cNvSpPr txBox="1"/>
          <p:nvPr/>
        </p:nvSpPr>
        <p:spPr>
          <a:xfrm>
            <a:off x="3593007" y="24890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SG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B247884-B72C-CB0C-DC88-7D01AB3CB93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5187" y="719136"/>
            <a:ext cx="3002280" cy="187642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BE90274-3162-BF74-3D14-1DF9195D7CD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45" y="719135"/>
            <a:ext cx="3002280" cy="18764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0314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654</Words>
  <Application>Microsoft Office PowerPoint</Application>
  <PresentationFormat>A4 Paper (210x297 mm)</PresentationFormat>
  <Paragraphs>36</Paragraphs>
  <Slides>7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g Zi Wei</dc:creator>
  <cp:lastModifiedBy>Chang Zi Wei</cp:lastModifiedBy>
  <cp:revision>4</cp:revision>
  <cp:lastPrinted>2023-09-14T08:33:19Z</cp:lastPrinted>
  <dcterms:created xsi:type="dcterms:W3CDTF">2022-01-24T11:44:42Z</dcterms:created>
  <dcterms:modified xsi:type="dcterms:W3CDTF">2026-03-05T15:48:13Z</dcterms:modified>
</cp:coreProperties>
</file>